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4"/>
  </p:notesMasterIdLst>
  <p:sldIdLst>
    <p:sldId id="437" r:id="rId2"/>
    <p:sldId id="262" r:id="rId3"/>
    <p:sldId id="272" r:id="rId4"/>
    <p:sldId id="264" r:id="rId5"/>
    <p:sldId id="265" r:id="rId6"/>
    <p:sldId id="266" r:id="rId7"/>
    <p:sldId id="282" r:id="rId8"/>
    <p:sldId id="278" r:id="rId9"/>
    <p:sldId id="279" r:id="rId10"/>
    <p:sldId id="280" r:id="rId11"/>
    <p:sldId id="269" r:id="rId12"/>
    <p:sldId id="270" r:id="rId1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AA0EC822-1D0A-A507-2EC1-86D8EE65D69B}" name="Lemonnier Claire" initials="LC" userId="S::Claire.Lemonnier@ucb.com::e0331745-7763-46b2-99ef-d93fed39c4dc" providerId="AD"/>
  <p188:author id="{2B23464D-8A8F-98CF-5072-E9853F64A573}" name="Ellis Mark" initials="ME" userId="S::Mark.Ellis@ucb.com::26765fe2-3f3a-4c6e-ae4a-a9037236a806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858" autoAdjust="0"/>
    <p:restoredTop sz="95858" autoAdjust="0"/>
  </p:normalViewPr>
  <p:slideViewPr>
    <p:cSldViewPr snapToGrid="0">
      <p:cViewPr varScale="1">
        <p:scale>
          <a:sx n="105" d="100"/>
          <a:sy n="105" d="100"/>
        </p:scale>
        <p:origin x="1304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19" Type="http://schemas.microsoft.com/office/2018/10/relationships/authors" Target="author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F89450E-9ED6-384C-94AE-BC5F569E2365}" type="datetimeFigureOut">
              <a:rPr lang="en-GB" smtClean="0"/>
              <a:t>14/10/202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156BA83-E027-174C-8C06-F842EA4E80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5164147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156BA83-E027-174C-8C06-F842EA4E8029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2186706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156BA83-E027-174C-8C06-F842EA4E8029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6229205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156BA83-E027-174C-8C06-F842EA4E8029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98891619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156BA83-E027-174C-8C06-F842EA4E8029}" type="slidenum">
              <a:rPr lang="en-GB" smtClean="0"/>
              <a:t>4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53984697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156BA83-E027-174C-8C06-F842EA4E8029}" type="slidenum">
              <a:rPr lang="en-GB" smtClean="0"/>
              <a:t>6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7494749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4A980E4-4744-4655-BB2C-ECABB8827CA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59ADE85-7EED-4994-B068-32D9803B840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E15B0C2-9260-4AA0-9525-EE4631FE4B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6C99B8-4E61-4948-A5B5-E446A2F616BE}" type="datetimeFigureOut">
              <a:rPr lang="en-GB" smtClean="0"/>
              <a:t>14/10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D23D5A4-DED5-4BFC-A649-68C1689B23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F0B494E-5207-4F00-992E-736B5C5E33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D00A7D-6CA4-4DEE-9AA1-7FF3A4B13AB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968107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74D5E2B-EA66-463A-9525-10AB080ABAF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006472B-5F59-4C4F-9697-A66C9441F1E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FA8449D-21C4-4466-BD6D-F0AB66C351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6C99B8-4E61-4948-A5B5-E446A2F616BE}" type="datetimeFigureOut">
              <a:rPr lang="en-GB" smtClean="0"/>
              <a:t>14/10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ED526CB-7B37-4647-8BD6-31E9491C54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FBD19EE-CDFE-4D11-93F7-109E2D2E53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D00A7D-6CA4-4DEE-9AA1-7FF3A4B13AB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209284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AC83099-69D3-4C4A-97DB-AAD53099EA2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8DCF456-F55C-4DC2-A6B6-85FEABE996E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7351ED4-3FE4-4551-AE7A-6712928EB9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6C99B8-4E61-4948-A5B5-E446A2F616BE}" type="datetimeFigureOut">
              <a:rPr lang="en-GB" smtClean="0"/>
              <a:t>14/10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2BDD566-A2AF-4279-B367-4A78BAD101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EB42D91-5287-4D59-A55D-9BE45E650A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D00A7D-6CA4-4DEE-9AA1-7FF3A4B13AB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286776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199B4D-3267-4CDD-A31B-4C829152A08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65E7B29-1EE1-4484-A368-3093F91C00E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18DA870-8FAF-47DB-9715-29A7B6D9A5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6C99B8-4E61-4948-A5B5-E446A2F616BE}" type="datetimeFigureOut">
              <a:rPr lang="en-GB" smtClean="0"/>
              <a:t>14/10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5F28E6A-66DF-411B-882C-90538658D0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D25F75F-20E0-4357-81B0-348D69AE8D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D00A7D-6CA4-4DEE-9AA1-7FF3A4B13AB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723492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2D012D-82AB-454B-A567-60BF8CB15B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95D1A3D-D37F-466D-8FB4-E86C2DB6B3B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B36C5E0-84C2-4948-9BBB-7A9CDDB62A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6C99B8-4E61-4948-A5B5-E446A2F616BE}" type="datetimeFigureOut">
              <a:rPr lang="en-GB" smtClean="0"/>
              <a:t>14/10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3720FA9-77C7-4067-9607-6A5B6A49AD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BF909F3-163B-43DA-8582-1523F622ED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D00A7D-6CA4-4DEE-9AA1-7FF3A4B13AB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820085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E64654-7033-493F-A426-E960EC99052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6AA334D-33AB-4FEC-8C3A-67A066F8D1A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21F79B9-AF2B-4D0E-9B26-82135A7E2B1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2533926-AD77-4292-9E04-841A1FE619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6C99B8-4E61-4948-A5B5-E446A2F616BE}" type="datetimeFigureOut">
              <a:rPr lang="en-GB" smtClean="0"/>
              <a:t>14/10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F6249BC-6980-431C-872A-4CD8FE4C84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2A55D3B-2938-4C86-B21B-FA605B2D32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D00A7D-6CA4-4DEE-9AA1-7FF3A4B13AB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01654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B2AECD-7AF1-40D7-A615-948A995311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E97BDDF-CC6D-4907-A483-EE70F5B9EB8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8DD159E-E9A0-4265-8BFD-13162220871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17B224A-D99C-4AFA-B540-454E7DB5454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BD6E5F7-5896-4623-B9F8-B95FDDB3A13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EAA6E3E-E047-42E2-A35E-EE93847F21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6C99B8-4E61-4948-A5B5-E446A2F616BE}" type="datetimeFigureOut">
              <a:rPr lang="en-GB" smtClean="0"/>
              <a:t>14/10/2024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E3C5DEB-E13B-4303-9839-2EBC6020C7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F66040A-5A72-4351-9977-6C680599B9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D00A7D-6CA4-4DEE-9AA1-7FF3A4B13AB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18032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B95910-4623-4D93-BFE5-6251AFDF72C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1AB5241-EE4A-4627-B660-E31B8ED9CC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6C99B8-4E61-4948-A5B5-E446A2F616BE}" type="datetimeFigureOut">
              <a:rPr lang="en-GB" smtClean="0"/>
              <a:t>14/10/2024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34CE298-C20B-42BE-9ACB-7DBBE6564E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826604F-3FA6-4037-9454-8CFBDA5725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D00A7D-6CA4-4DEE-9AA1-7FF3A4B13AB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654094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C2C60E9-4D53-4A0A-88AC-9F68DEA696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6C99B8-4E61-4948-A5B5-E446A2F616BE}" type="datetimeFigureOut">
              <a:rPr lang="en-GB" smtClean="0"/>
              <a:t>14/10/2024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FAA849E-033A-463D-AFBE-784A1E52FB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935F942-9FF1-4485-A7D9-BFD3BA6E4E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D00A7D-6CA4-4DEE-9AA1-7FF3A4B13AB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340547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ECD53D-E51E-4F99-A8E4-CD1A2D2759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FA04472-930A-4D2B-886C-D8875B04AC8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686013D-1518-40BD-8A71-4232351DDA5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74E4C2D-CBF1-4287-8B82-1FCE6C4566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6C99B8-4E61-4948-A5B5-E446A2F616BE}" type="datetimeFigureOut">
              <a:rPr lang="en-GB" smtClean="0"/>
              <a:t>14/10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C67AABF-757F-462F-82ED-152F994100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FB07AAC-8EC8-47B8-BA39-D8C89B8CD1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D00A7D-6CA4-4DEE-9AA1-7FF3A4B13AB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5760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327D2D-18A7-4671-91FD-1D8410E8A4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06E764A-CA0B-4BA7-9004-AACA4188041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C382259-5D1D-409A-AD95-90052937146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E66C73B-AE7E-4ADA-8714-C90EB47726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6C99B8-4E61-4948-A5B5-E446A2F616BE}" type="datetimeFigureOut">
              <a:rPr lang="en-GB" smtClean="0"/>
              <a:t>14/10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0CD3FC1-3239-4791-A341-FA37A49884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49774A0-47A7-4997-96C7-C8107E10EE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D00A7D-6CA4-4DEE-9AA1-7FF3A4B13AB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519221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042305A-D9C4-4C0B-BF29-376802707DA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33270FA-C3A8-4487-9CBC-78AF11443E4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25A9B3F-1C69-41AD-BFE9-1733470F417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6C99B8-4E61-4948-A5B5-E446A2F616BE}" type="datetimeFigureOut">
              <a:rPr lang="en-GB" smtClean="0"/>
              <a:t>14/10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D5D751E-2619-45D7-83A6-2CDF6B83F35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A077937-45F0-46B6-81E9-B720F001690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D00A7D-6CA4-4DEE-9AA1-7FF3A4B13AB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426347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emf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jp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jp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6.emf"/><Relationship Id="rId4" Type="http://schemas.openxmlformats.org/officeDocument/2006/relationships/image" Target="../media/image2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emf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A45774C0-B6F4-F0A0-130E-B77B61E4A935}"/>
              </a:ext>
            </a:extLst>
          </p:cNvPr>
          <p:cNvSpPr txBox="1"/>
          <p:nvPr/>
        </p:nvSpPr>
        <p:spPr>
          <a:xfrm>
            <a:off x="102007" y="6017468"/>
            <a:ext cx="1205932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600" b="1" dirty="0"/>
              <a:t>Supplementary Schematic 1</a:t>
            </a:r>
            <a:r>
              <a:rPr lang="en-US" sz="1600" dirty="0"/>
              <a:t>: </a:t>
            </a:r>
            <a:r>
              <a:rPr lang="en-GB" sz="1600" dirty="0"/>
              <a:t>Schematic of the expression vector configuration used for the generation of stabling expressing </a:t>
            </a:r>
            <a:r>
              <a:rPr lang="en-GB" sz="1600" kern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Ybe</a:t>
            </a:r>
            <a:r>
              <a:rPr lang="en-GB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®</a:t>
            </a:r>
            <a:r>
              <a:rPr lang="en-GB" sz="1600" dirty="0"/>
              <a:t> CHO-DG44 cell pools. DHFR selection marker, double vector gene configuration shown alongside the promoters used to drive expression.</a:t>
            </a:r>
            <a:endParaRPr lang="en-US" sz="1600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F67D21E4-D527-D6BA-524F-D4ED22C686C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10456" y="255756"/>
            <a:ext cx="7739734" cy="57617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1173153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11">
            <a:extLst>
              <a:ext uri="{FF2B5EF4-FFF2-40B4-BE49-F238E27FC236}">
                <a16:creationId xmlns:a16="http://schemas.microsoft.com/office/drawing/2014/main" id="{EFA067F4-511E-41C6-9750-1F0F901A2A7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137436" y="1898352"/>
            <a:ext cx="2391418" cy="1416519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EC8E3806-2C12-724C-AA39-0D11C57B5BC3}"/>
              </a:ext>
            </a:extLst>
          </p:cNvPr>
          <p:cNvSpPr txBox="1"/>
          <p:nvPr/>
        </p:nvSpPr>
        <p:spPr>
          <a:xfrm>
            <a:off x="253969" y="5224172"/>
            <a:ext cx="11735578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600" b="1" dirty="0"/>
              <a:t>Supplementary Figure 9: Analysis of intracellular and secreted heavy and light chain in cell lysate and culture medium samples under non-reducing conditions. </a:t>
            </a:r>
            <a:r>
              <a:rPr lang="en-GB" sz="1600" dirty="0"/>
              <a:t>Cell pellets and culture supernatant was harvested on day 6 of culture (exponential growth phase) for intracellular (IC) and secreted (M) protein analysis. Samples were analysed by western blot under non-reducing conditions. Images are shown for the light chain detection. Data is shown for top (R1) and bottom (R12) ranking mini-pools selected for each cell line. A cell lysate sample from the non-transfected host cell line culture (Host </a:t>
            </a:r>
            <a:r>
              <a:rPr lang="en-GB" sz="1600" dirty="0" err="1"/>
              <a:t>Ctl</a:t>
            </a:r>
            <a:r>
              <a:rPr lang="en-GB" sz="1600" dirty="0"/>
              <a:t>) was used as a negative control. A commercial IgG was used as a positive control (IgG control). Data shown is representative of at least three replicates.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05EC79EA-566F-3148-950A-C3E8053BA58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53969" y="743952"/>
            <a:ext cx="8521700" cy="4343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5732586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>
            <a:extLst>
              <a:ext uri="{FF2B5EF4-FFF2-40B4-BE49-F238E27FC236}">
                <a16:creationId xmlns:a16="http://schemas.microsoft.com/office/drawing/2014/main" id="{B09B9A0A-52F7-44EB-B93A-23A342B049C9}"/>
              </a:ext>
            </a:extLst>
          </p:cNvPr>
          <p:cNvSpPr/>
          <p:nvPr/>
        </p:nvSpPr>
        <p:spPr>
          <a:xfrm>
            <a:off x="146304" y="5548751"/>
            <a:ext cx="11686032" cy="107721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600" b="1" dirty="0">
                <a:latin typeface="Calibri-Bold"/>
              </a:rPr>
              <a:t>Supplementary Figure 10: genomic DNA analysis of all </a:t>
            </a:r>
            <a:r>
              <a:rPr lang="en-GB" sz="1600" b="1" kern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Ybe</a:t>
            </a:r>
            <a:r>
              <a:rPr lang="en-GB" sz="16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®</a:t>
            </a:r>
            <a:r>
              <a:rPr lang="en-GB" sz="1600" b="1" dirty="0">
                <a:latin typeface="Calibri-Bold"/>
              </a:rPr>
              <a:t> mini-pools. </a:t>
            </a:r>
            <a:r>
              <a:rPr lang="en-GB" sz="1600" dirty="0">
                <a:latin typeface="Calibri" panose="020F0502020204030204" pitchFamily="34" charset="0"/>
              </a:rPr>
              <a:t>Cell pellets were collected on day 6 of culture for gDNA analysis. Light and heavy chain gDNA copies per cell were quantified for 6 of the mini pools. Light chain gDNA copies were plotted against molecules/cell/day for </a:t>
            </a:r>
            <a:r>
              <a:rPr lang="en-GB" sz="1600" kern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Ybe</a:t>
            </a:r>
            <a:r>
              <a:rPr lang="en-GB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®</a:t>
            </a:r>
            <a:r>
              <a:rPr lang="en-GB" sz="1600" dirty="0">
                <a:latin typeface="Calibri" panose="020F0502020204030204" pitchFamily="34" charset="0"/>
              </a:rPr>
              <a:t> LCA (</a:t>
            </a:r>
            <a:r>
              <a:rPr lang="en-GB" sz="1600" b="1" dirty="0">
                <a:latin typeface="Calibri" panose="020F0502020204030204" pitchFamily="34" charset="0"/>
              </a:rPr>
              <a:t>A</a:t>
            </a:r>
            <a:r>
              <a:rPr lang="en-GB" sz="1600" dirty="0">
                <a:latin typeface="Calibri" panose="020F0502020204030204" pitchFamily="34" charset="0"/>
              </a:rPr>
              <a:t>), </a:t>
            </a:r>
            <a:r>
              <a:rPr lang="en-GB" sz="1600" kern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Ybe</a:t>
            </a:r>
            <a:r>
              <a:rPr lang="en-GB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®</a:t>
            </a:r>
            <a:r>
              <a:rPr lang="en-GB" sz="1600" dirty="0">
                <a:latin typeface="Calibri" panose="020F0502020204030204" pitchFamily="34" charset="0"/>
              </a:rPr>
              <a:t> LCB (</a:t>
            </a:r>
            <a:r>
              <a:rPr lang="en-GB" sz="1600" b="1" dirty="0">
                <a:latin typeface="Calibri" panose="020F0502020204030204" pitchFamily="34" charset="0"/>
              </a:rPr>
              <a:t>B</a:t>
            </a:r>
            <a:r>
              <a:rPr lang="en-GB" sz="1600" dirty="0">
                <a:latin typeface="Calibri" panose="020F0502020204030204" pitchFamily="34" charset="0"/>
              </a:rPr>
              <a:t>), </a:t>
            </a:r>
            <a:r>
              <a:rPr lang="en-GB" sz="1600" kern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Ybe</a:t>
            </a:r>
            <a:r>
              <a:rPr lang="en-GB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®</a:t>
            </a:r>
            <a:r>
              <a:rPr lang="en-GB" sz="1600" dirty="0">
                <a:latin typeface="Calibri" panose="020F0502020204030204" pitchFamily="34" charset="0"/>
              </a:rPr>
              <a:t> HCA (</a:t>
            </a:r>
            <a:r>
              <a:rPr lang="en-GB" sz="1600" b="1" dirty="0">
                <a:latin typeface="Calibri" panose="020F0502020204030204" pitchFamily="34" charset="0"/>
              </a:rPr>
              <a:t>C</a:t>
            </a:r>
            <a:r>
              <a:rPr lang="en-GB" sz="1600" dirty="0">
                <a:latin typeface="Calibri" panose="020F0502020204030204" pitchFamily="34" charset="0"/>
              </a:rPr>
              <a:t>) and </a:t>
            </a:r>
            <a:r>
              <a:rPr lang="en-GB" sz="1600" kern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Ybe</a:t>
            </a:r>
            <a:r>
              <a:rPr lang="en-GB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®</a:t>
            </a:r>
            <a:r>
              <a:rPr lang="en-GB" sz="1600" dirty="0">
                <a:latin typeface="Calibri" panose="020F0502020204030204" pitchFamily="34" charset="0"/>
              </a:rPr>
              <a:t> HCB (</a:t>
            </a:r>
            <a:r>
              <a:rPr lang="en-GB" sz="1600" b="1" dirty="0">
                <a:latin typeface="Calibri" panose="020F0502020204030204" pitchFamily="34" charset="0"/>
              </a:rPr>
              <a:t>D</a:t>
            </a:r>
            <a:r>
              <a:rPr lang="en-GB" sz="1600" dirty="0">
                <a:latin typeface="Calibri" panose="020F0502020204030204" pitchFamily="34" charset="0"/>
              </a:rPr>
              <a:t>). Heavy chain gDNA copies were also plotted against molecules/cell/day for </a:t>
            </a:r>
            <a:r>
              <a:rPr lang="en-GB" sz="1600" kern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Ybe</a:t>
            </a:r>
            <a:r>
              <a:rPr lang="en-GB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®</a:t>
            </a:r>
            <a:r>
              <a:rPr lang="en-GB" sz="1600" dirty="0">
                <a:latin typeface="Calibri" panose="020F0502020204030204" pitchFamily="34" charset="0"/>
              </a:rPr>
              <a:t> LCA (</a:t>
            </a:r>
            <a:r>
              <a:rPr lang="en-GB" sz="1600" b="1" dirty="0">
                <a:latin typeface="Calibri" panose="020F0502020204030204" pitchFamily="34" charset="0"/>
              </a:rPr>
              <a:t>E</a:t>
            </a:r>
            <a:r>
              <a:rPr lang="en-GB" sz="1600" dirty="0">
                <a:latin typeface="Calibri" panose="020F0502020204030204" pitchFamily="34" charset="0"/>
              </a:rPr>
              <a:t>), </a:t>
            </a:r>
            <a:r>
              <a:rPr lang="en-GB" sz="1600" kern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Ybe</a:t>
            </a:r>
            <a:r>
              <a:rPr lang="en-GB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®</a:t>
            </a:r>
            <a:r>
              <a:rPr lang="en-GB" sz="1600" dirty="0">
                <a:latin typeface="Calibri" panose="020F0502020204030204" pitchFamily="34" charset="0"/>
              </a:rPr>
              <a:t> LCB (</a:t>
            </a:r>
            <a:r>
              <a:rPr lang="en-GB" sz="1600" b="1" dirty="0">
                <a:latin typeface="Calibri" panose="020F0502020204030204" pitchFamily="34" charset="0"/>
              </a:rPr>
              <a:t>F</a:t>
            </a:r>
            <a:r>
              <a:rPr lang="en-GB" sz="1600" dirty="0">
                <a:latin typeface="Calibri" panose="020F0502020204030204" pitchFamily="34" charset="0"/>
              </a:rPr>
              <a:t>), </a:t>
            </a:r>
            <a:r>
              <a:rPr lang="en-GB" sz="1600" kern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Ybe</a:t>
            </a:r>
            <a:r>
              <a:rPr lang="en-GB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®</a:t>
            </a:r>
            <a:r>
              <a:rPr lang="en-GB" sz="1600" dirty="0">
                <a:latin typeface="Calibri" panose="020F0502020204030204" pitchFamily="34" charset="0"/>
              </a:rPr>
              <a:t> HCA (</a:t>
            </a:r>
            <a:r>
              <a:rPr lang="en-GB" sz="1600" b="1" dirty="0">
                <a:latin typeface="Calibri" panose="020F0502020204030204" pitchFamily="34" charset="0"/>
              </a:rPr>
              <a:t>G</a:t>
            </a:r>
            <a:r>
              <a:rPr lang="en-GB" sz="1600" dirty="0">
                <a:latin typeface="Calibri" panose="020F0502020204030204" pitchFamily="34" charset="0"/>
              </a:rPr>
              <a:t>) and </a:t>
            </a:r>
            <a:r>
              <a:rPr lang="en-GB" sz="1600" kern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Ybe</a:t>
            </a:r>
            <a:r>
              <a:rPr lang="en-GB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®</a:t>
            </a:r>
            <a:r>
              <a:rPr lang="en-GB" sz="1600" dirty="0">
                <a:latin typeface="Calibri" panose="020F0502020204030204" pitchFamily="34" charset="0"/>
              </a:rPr>
              <a:t> HCB (</a:t>
            </a:r>
            <a:r>
              <a:rPr lang="en-GB" sz="1600" b="1" dirty="0">
                <a:latin typeface="Calibri" panose="020F0502020204030204" pitchFamily="34" charset="0"/>
              </a:rPr>
              <a:t>H</a:t>
            </a:r>
            <a:r>
              <a:rPr lang="en-GB" sz="1600" dirty="0">
                <a:latin typeface="Calibri" panose="020F0502020204030204" pitchFamily="34" charset="0"/>
              </a:rPr>
              <a:t>). </a:t>
            </a:r>
            <a:endParaRPr lang="en-GB" dirty="0">
              <a:latin typeface="Calibri" panose="020F0502020204030204" pitchFamily="34" charset="0"/>
            </a:endParaRPr>
          </a:p>
        </p:txBody>
      </p:sp>
      <p:pic>
        <p:nvPicPr>
          <p:cNvPr id="4" name="Picture 3" descr="Graphical user interface&#10;&#10;Description automatically generated">
            <a:extLst>
              <a:ext uri="{FF2B5EF4-FFF2-40B4-BE49-F238E27FC236}">
                <a16:creationId xmlns:a16="http://schemas.microsoft.com/office/drawing/2014/main" id="{5C8C5960-C78B-4F38-A552-559A815BB96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550416"/>
            <a:ext cx="11832336" cy="498652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43528749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>
            <a:extLst>
              <a:ext uri="{FF2B5EF4-FFF2-40B4-BE49-F238E27FC236}">
                <a16:creationId xmlns:a16="http://schemas.microsoft.com/office/drawing/2014/main" id="{90455036-4BE3-4935-A553-43731C8DDC43}"/>
              </a:ext>
            </a:extLst>
          </p:cNvPr>
          <p:cNvSpPr/>
          <p:nvPr/>
        </p:nvSpPr>
        <p:spPr>
          <a:xfrm>
            <a:off x="134113" y="5608702"/>
            <a:ext cx="11838432" cy="12464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500" b="1" dirty="0">
                <a:latin typeface="Calibri-Bold"/>
              </a:rPr>
              <a:t>Supplementary Figure 11: Comparison of genomic DNA copy number and messenger RNA transcript number and heavy chain to light chain mRNA ratio analysis. </a:t>
            </a:r>
            <a:r>
              <a:rPr lang="en-GB" sz="1500" dirty="0">
                <a:latin typeface="Calibri" panose="020F0502020204030204" pitchFamily="34" charset="0"/>
              </a:rPr>
              <a:t>Cell pellets were collected on day 6 of culture for gDNA and mRNA analysis. Light and heavy chain gDNA copies per cell and mRNA transcripts were quantified for 6 of the mini pools. The gDNA data was plotted against the mRNA data for </a:t>
            </a:r>
            <a:r>
              <a:rPr lang="en-GB" sz="1400" kern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Ybe</a:t>
            </a:r>
            <a:r>
              <a:rPr lang="en-GB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®</a:t>
            </a:r>
            <a:r>
              <a:rPr lang="en-GB" sz="1500" dirty="0">
                <a:latin typeface="Calibri" panose="020F0502020204030204" pitchFamily="34" charset="0"/>
              </a:rPr>
              <a:t> LCA (</a:t>
            </a:r>
            <a:r>
              <a:rPr lang="en-GB" sz="1500" b="1" dirty="0">
                <a:latin typeface="Calibri" panose="020F0502020204030204" pitchFamily="34" charset="0"/>
              </a:rPr>
              <a:t>A, B</a:t>
            </a:r>
            <a:r>
              <a:rPr lang="en-GB" sz="1500" dirty="0">
                <a:latin typeface="Calibri" panose="020F0502020204030204" pitchFamily="34" charset="0"/>
              </a:rPr>
              <a:t>), </a:t>
            </a:r>
            <a:r>
              <a:rPr lang="en-GB" sz="1400" kern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Ybe</a:t>
            </a:r>
            <a:r>
              <a:rPr lang="en-GB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®</a:t>
            </a:r>
            <a:r>
              <a:rPr lang="en-GB" sz="1500" dirty="0">
                <a:latin typeface="Calibri" panose="020F0502020204030204" pitchFamily="34" charset="0"/>
              </a:rPr>
              <a:t> LCB (</a:t>
            </a:r>
            <a:r>
              <a:rPr lang="en-GB" sz="1500" b="1" dirty="0">
                <a:latin typeface="Calibri" panose="020F0502020204030204" pitchFamily="34" charset="0"/>
              </a:rPr>
              <a:t>D, E</a:t>
            </a:r>
            <a:r>
              <a:rPr lang="en-GB" sz="1500" dirty="0">
                <a:latin typeface="Calibri" panose="020F0502020204030204" pitchFamily="34" charset="0"/>
              </a:rPr>
              <a:t>), </a:t>
            </a:r>
            <a:r>
              <a:rPr lang="en-GB" sz="1400" kern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Ybe</a:t>
            </a:r>
            <a:r>
              <a:rPr lang="en-GB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®</a:t>
            </a:r>
            <a:r>
              <a:rPr lang="en-GB" sz="1500" dirty="0">
                <a:latin typeface="Calibri" panose="020F0502020204030204" pitchFamily="34" charset="0"/>
              </a:rPr>
              <a:t> HCA (</a:t>
            </a:r>
            <a:r>
              <a:rPr lang="en-GB" sz="1500" b="1" dirty="0">
                <a:latin typeface="Calibri" panose="020F0502020204030204" pitchFamily="34" charset="0"/>
              </a:rPr>
              <a:t>G, H</a:t>
            </a:r>
            <a:r>
              <a:rPr lang="en-GB" sz="1500" dirty="0">
                <a:latin typeface="Calibri" panose="020F0502020204030204" pitchFamily="34" charset="0"/>
              </a:rPr>
              <a:t>) and </a:t>
            </a:r>
            <a:r>
              <a:rPr lang="en-GB" sz="1400" kern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Ybe</a:t>
            </a:r>
            <a:r>
              <a:rPr lang="en-GB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®</a:t>
            </a:r>
            <a:r>
              <a:rPr lang="en-GB" sz="1500" dirty="0">
                <a:latin typeface="Calibri" panose="020F0502020204030204" pitchFamily="34" charset="0"/>
              </a:rPr>
              <a:t> HCB (</a:t>
            </a:r>
            <a:r>
              <a:rPr lang="en-GB" sz="1500" b="1" dirty="0">
                <a:latin typeface="Calibri" panose="020F0502020204030204" pitchFamily="34" charset="0"/>
              </a:rPr>
              <a:t>J, K</a:t>
            </a:r>
            <a:r>
              <a:rPr lang="en-GB" sz="1500" dirty="0">
                <a:latin typeface="Calibri" panose="020F0502020204030204" pitchFamily="34" charset="0"/>
              </a:rPr>
              <a:t>) for light and heavy chain respectively. The ratio of heavy chain to light chain mRNA was also plotted against the molecules/cell/day for </a:t>
            </a:r>
            <a:r>
              <a:rPr lang="en-GB" sz="1400" kern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Ybe</a:t>
            </a:r>
            <a:r>
              <a:rPr lang="en-GB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®</a:t>
            </a:r>
            <a:r>
              <a:rPr lang="en-GB" sz="1500" dirty="0">
                <a:latin typeface="Calibri" panose="020F0502020204030204" pitchFamily="34" charset="0"/>
              </a:rPr>
              <a:t> LCA (</a:t>
            </a:r>
            <a:r>
              <a:rPr lang="en-GB" sz="1500" b="1" dirty="0">
                <a:latin typeface="Calibri" panose="020F0502020204030204" pitchFamily="34" charset="0"/>
              </a:rPr>
              <a:t>C</a:t>
            </a:r>
            <a:r>
              <a:rPr lang="en-GB" sz="1500" dirty="0">
                <a:latin typeface="Calibri" panose="020F0502020204030204" pitchFamily="34" charset="0"/>
              </a:rPr>
              <a:t>), </a:t>
            </a:r>
            <a:r>
              <a:rPr lang="en-GB" sz="1400" kern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Ybe</a:t>
            </a:r>
            <a:r>
              <a:rPr lang="en-GB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®</a:t>
            </a:r>
            <a:r>
              <a:rPr lang="en-GB" sz="1500" dirty="0">
                <a:latin typeface="Calibri" panose="020F0502020204030204" pitchFamily="34" charset="0"/>
              </a:rPr>
              <a:t> LCB (</a:t>
            </a:r>
            <a:r>
              <a:rPr lang="en-GB" sz="1500" b="1" dirty="0">
                <a:latin typeface="Calibri" panose="020F0502020204030204" pitchFamily="34" charset="0"/>
              </a:rPr>
              <a:t>F</a:t>
            </a:r>
            <a:r>
              <a:rPr lang="en-GB" sz="1500" dirty="0">
                <a:latin typeface="Calibri" panose="020F0502020204030204" pitchFamily="34" charset="0"/>
              </a:rPr>
              <a:t>), </a:t>
            </a:r>
            <a:r>
              <a:rPr lang="en-GB" sz="1400" kern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Ybe</a:t>
            </a:r>
            <a:r>
              <a:rPr lang="en-GB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®</a:t>
            </a:r>
            <a:r>
              <a:rPr lang="en-GB" sz="1500" dirty="0">
                <a:latin typeface="Calibri" panose="020F0502020204030204" pitchFamily="34" charset="0"/>
              </a:rPr>
              <a:t> HCA (</a:t>
            </a:r>
            <a:r>
              <a:rPr lang="en-GB" sz="1500" b="1" dirty="0">
                <a:latin typeface="Calibri" panose="020F0502020204030204" pitchFamily="34" charset="0"/>
              </a:rPr>
              <a:t>I</a:t>
            </a:r>
            <a:r>
              <a:rPr lang="en-GB" sz="1500" dirty="0">
                <a:latin typeface="Calibri" panose="020F0502020204030204" pitchFamily="34" charset="0"/>
              </a:rPr>
              <a:t>) and </a:t>
            </a:r>
            <a:r>
              <a:rPr lang="en-GB" sz="1400" kern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Ybe</a:t>
            </a:r>
            <a:r>
              <a:rPr lang="en-GB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®</a:t>
            </a:r>
            <a:r>
              <a:rPr lang="en-GB" sz="1500" dirty="0">
                <a:latin typeface="Calibri" panose="020F0502020204030204" pitchFamily="34" charset="0"/>
              </a:rPr>
              <a:t> HCB (</a:t>
            </a:r>
            <a:r>
              <a:rPr lang="en-GB" sz="1500" b="1" dirty="0">
                <a:latin typeface="Calibri" panose="020F0502020204030204" pitchFamily="34" charset="0"/>
              </a:rPr>
              <a:t>L</a:t>
            </a:r>
            <a:r>
              <a:rPr lang="en-GB" sz="1500" dirty="0">
                <a:latin typeface="Calibri" panose="020F0502020204030204" pitchFamily="34" charset="0"/>
              </a:rPr>
              <a:t>).</a:t>
            </a:r>
            <a:endParaRPr lang="en-GB" sz="1500" dirty="0"/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BB5CB5D4-3472-4D7C-A376-1B5EBBD06DD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643492" y="2294829"/>
            <a:ext cx="2499740" cy="1480682"/>
          </a:xfrm>
          <a:prstGeom prst="rect">
            <a:avLst/>
          </a:prstGeom>
        </p:spPr>
      </p:pic>
      <p:pic>
        <p:nvPicPr>
          <p:cNvPr id="7" name="Picture 6" descr="Calendar&#10;&#10;Description automatically generated">
            <a:extLst>
              <a:ext uri="{FF2B5EF4-FFF2-40B4-BE49-F238E27FC236}">
                <a16:creationId xmlns:a16="http://schemas.microsoft.com/office/drawing/2014/main" id="{B395ADDC-0311-48F4-A2C1-E53EA7F108D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4112" y="109728"/>
            <a:ext cx="9385583" cy="554289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5020076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4F9887B0-57D0-A949-B1D1-72AFDCA78B9C}"/>
              </a:ext>
            </a:extLst>
          </p:cNvPr>
          <p:cNvSpPr txBox="1"/>
          <p:nvPr/>
        </p:nvSpPr>
        <p:spPr>
          <a:xfrm>
            <a:off x="102007" y="6017468"/>
            <a:ext cx="12059327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600" b="1" dirty="0"/>
              <a:t>Supplementary Figure 1</a:t>
            </a:r>
            <a:r>
              <a:rPr lang="en-US" sz="1600" dirty="0"/>
              <a:t>: </a:t>
            </a:r>
            <a:r>
              <a:rPr lang="en-US" sz="1600" b="1" dirty="0"/>
              <a:t>Cell growth data for the Top 12 mini-pools for each molecule. </a:t>
            </a:r>
            <a:r>
              <a:rPr lang="en-US" sz="1600" dirty="0"/>
              <a:t>The total cell density (</a:t>
            </a:r>
            <a:r>
              <a:rPr lang="en-US" sz="1600" i="1" dirty="0"/>
              <a:t>solid lines, primary y-axis, x 10</a:t>
            </a:r>
            <a:r>
              <a:rPr lang="en-US" sz="1600" i="1" baseline="30000" dirty="0"/>
              <a:t>6</a:t>
            </a:r>
            <a:r>
              <a:rPr lang="en-US" sz="1600" i="1" dirty="0"/>
              <a:t> cells/ml, log scale</a:t>
            </a:r>
            <a:r>
              <a:rPr lang="en-US" sz="1600" dirty="0"/>
              <a:t>) and culture viability (</a:t>
            </a:r>
            <a:r>
              <a:rPr lang="en-US" sz="1600" i="1" dirty="0"/>
              <a:t>dashed line, secondary y-axis</a:t>
            </a:r>
            <a:r>
              <a:rPr lang="en-US" sz="1600" dirty="0"/>
              <a:t>) were monitored for the the top 12 stably-transfected mini-pools for each </a:t>
            </a:r>
            <a:r>
              <a:rPr lang="en-GB" sz="1600" kern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Ybe</a:t>
            </a:r>
            <a:r>
              <a:rPr lang="en-GB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®</a:t>
            </a:r>
            <a:r>
              <a:rPr lang="en-US" sz="1600" dirty="0"/>
              <a:t> format over a 9-day batch culture. Mini-pool numbers are shown as a figure legend next to each plot.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3FCEEEF1-14ED-4C34-A79D-19BDF5C1BB8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785083" y="2062005"/>
            <a:ext cx="1563451" cy="926086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4A03B654-2A76-044E-9679-82D0CF4ABD7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14301" y="495915"/>
            <a:ext cx="9234498" cy="5562092"/>
          </a:xfrm>
          <a:prstGeom prst="rect">
            <a:avLst/>
          </a:prstGeom>
        </p:spPr>
      </p:pic>
      <p:sp>
        <p:nvSpPr>
          <p:cNvPr id="10" name="Rectangle 9">
            <a:extLst>
              <a:ext uri="{FF2B5EF4-FFF2-40B4-BE49-F238E27FC236}">
                <a16:creationId xmlns:a16="http://schemas.microsoft.com/office/drawing/2014/main" id="{F35C1FDB-3FB5-BD49-8BE7-A6A341A0F9E8}"/>
              </a:ext>
            </a:extLst>
          </p:cNvPr>
          <p:cNvSpPr/>
          <p:nvPr/>
        </p:nvSpPr>
        <p:spPr>
          <a:xfrm>
            <a:off x="102007" y="492345"/>
            <a:ext cx="7885156" cy="31393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/>
              <a:t>A                                                                                      B</a:t>
            </a:r>
          </a:p>
          <a:p>
            <a:endParaRPr lang="en-GB" b="1" dirty="0"/>
          </a:p>
          <a:p>
            <a:endParaRPr lang="en-GB" b="1" dirty="0"/>
          </a:p>
          <a:p>
            <a:endParaRPr lang="en-GB" b="1" dirty="0"/>
          </a:p>
          <a:p>
            <a:endParaRPr lang="en-GB" b="1" dirty="0"/>
          </a:p>
          <a:p>
            <a:endParaRPr lang="en-GB" b="1" dirty="0"/>
          </a:p>
          <a:p>
            <a:endParaRPr lang="en-GB" b="1" dirty="0"/>
          </a:p>
          <a:p>
            <a:endParaRPr lang="en-GB" b="1" dirty="0"/>
          </a:p>
          <a:p>
            <a:endParaRPr lang="en-GB" b="1" dirty="0"/>
          </a:p>
          <a:p>
            <a:endParaRPr lang="en-GB" b="1" dirty="0"/>
          </a:p>
          <a:p>
            <a:r>
              <a:rPr lang="en-GB" b="1" dirty="0"/>
              <a:t>C                                                                                      D</a:t>
            </a:r>
          </a:p>
        </p:txBody>
      </p:sp>
    </p:spTree>
    <p:extLst>
      <p:ext uri="{BB962C8B-B14F-4D97-AF65-F5344CB8AC3E}">
        <p14:creationId xmlns:p14="http://schemas.microsoft.com/office/powerpoint/2010/main" val="162073057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27AC2031-49E2-9F44-AC9A-27D4FF9E76E3}"/>
              </a:ext>
            </a:extLst>
          </p:cNvPr>
          <p:cNvSpPr txBox="1"/>
          <p:nvPr/>
        </p:nvSpPr>
        <p:spPr>
          <a:xfrm>
            <a:off x="8726906" y="530435"/>
            <a:ext cx="3342796" cy="49398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500" b="1" dirty="0"/>
              <a:t>Supplementary Figure 2: The specific growth rate and doubling time across all </a:t>
            </a:r>
            <a:r>
              <a:rPr lang="en-GB" sz="1400" b="1" kern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Ybe</a:t>
            </a:r>
            <a:r>
              <a:rPr lang="en-GB" sz="14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®</a:t>
            </a:r>
            <a:r>
              <a:rPr lang="en-US" sz="1500" b="1" dirty="0"/>
              <a:t> mini-pools. </a:t>
            </a:r>
            <a:r>
              <a:rPr lang="en-US" sz="1500" dirty="0"/>
              <a:t>The graphs summarises the specific growth rate (</a:t>
            </a:r>
            <a:r>
              <a:rPr lang="en-US" sz="1500" b="1" dirty="0"/>
              <a:t>A</a:t>
            </a:r>
            <a:r>
              <a:rPr lang="en-US" sz="1500" dirty="0"/>
              <a:t>) and doubling time (</a:t>
            </a:r>
            <a:r>
              <a:rPr lang="en-US" sz="1500" b="1" dirty="0"/>
              <a:t>B</a:t>
            </a:r>
            <a:r>
              <a:rPr lang="en-US" sz="1500" dirty="0"/>
              <a:t>) for the top 12 mini-pools for each </a:t>
            </a:r>
            <a:r>
              <a:rPr lang="en-GB" sz="1400" kern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Ybe</a:t>
            </a:r>
            <a:r>
              <a:rPr lang="en-GB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®</a:t>
            </a:r>
            <a:r>
              <a:rPr lang="en-US" sz="1500" dirty="0"/>
              <a:t> molecule. The specific growth rate (</a:t>
            </a:r>
            <a:r>
              <a:rPr lang="en-US" sz="1500" i="1" dirty="0"/>
              <a:t>µ, h</a:t>
            </a:r>
            <a:r>
              <a:rPr lang="en-US" sz="1500" i="1" baseline="30000" dirty="0"/>
              <a:t>-1</a:t>
            </a:r>
            <a:r>
              <a:rPr lang="en-US" sz="1500" dirty="0"/>
              <a:t>) was calculated using the viable cell concentration (x10</a:t>
            </a:r>
            <a:r>
              <a:rPr lang="en-US" sz="1500" baseline="30000" dirty="0"/>
              <a:t>6</a:t>
            </a:r>
            <a:r>
              <a:rPr lang="en-US" sz="1500" dirty="0"/>
              <a:t> cells/ml) over 48 h and 96 h of culture and the doubling time (</a:t>
            </a:r>
            <a:r>
              <a:rPr lang="en-US" sz="1500" i="1" dirty="0"/>
              <a:t>h</a:t>
            </a:r>
            <a:r>
              <a:rPr lang="en-US" sz="1500" dirty="0"/>
              <a:t>) was calculated over the same time period. The mean (n=12) for each data set is shown by the solid black bar. </a:t>
            </a:r>
            <a:r>
              <a:rPr lang="en-GB" sz="1500" dirty="0"/>
              <a:t>Statistical analysis by one-way ANOVA is shown on the graphs and high detailed in the table, where P values of &lt;0.05 (*), &lt;0.01(**), &lt;0.001(***) and &lt;0.0001(****) were deemed significantly different. Comparisons that were not deemed statistically significant (ns) are also highlighted.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EBFEAFCD-FD8B-4B01-ACA0-11BF548C5F1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834853" y="5629677"/>
            <a:ext cx="1563451" cy="926086"/>
          </a:xfrm>
          <a:prstGeom prst="rect">
            <a:avLst/>
          </a:prstGeom>
        </p:spPr>
      </p:pic>
      <p:graphicFrame>
        <p:nvGraphicFramePr>
          <p:cNvPr id="10" name="Table 9">
            <a:extLst>
              <a:ext uri="{FF2B5EF4-FFF2-40B4-BE49-F238E27FC236}">
                <a16:creationId xmlns:a16="http://schemas.microsoft.com/office/drawing/2014/main" id="{976DC143-36BF-CA48-8844-49B3455D50C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77983182"/>
              </p:ext>
            </p:extLst>
          </p:nvPr>
        </p:nvGraphicFramePr>
        <p:xfrm>
          <a:off x="237612" y="3976034"/>
          <a:ext cx="7236170" cy="2332586"/>
        </p:xfrm>
        <a:graphic>
          <a:graphicData uri="http://schemas.openxmlformats.org/drawingml/2006/table">
            <a:tbl>
              <a:tblPr/>
              <a:tblGrid>
                <a:gridCol w="1502997">
                  <a:extLst>
                    <a:ext uri="{9D8B030D-6E8A-4147-A177-3AD203B41FA5}">
                      <a16:colId xmlns:a16="http://schemas.microsoft.com/office/drawing/2014/main" val="1752265350"/>
                    </a:ext>
                  </a:extLst>
                </a:gridCol>
                <a:gridCol w="1163610">
                  <a:extLst>
                    <a:ext uri="{9D8B030D-6E8A-4147-A177-3AD203B41FA5}">
                      <a16:colId xmlns:a16="http://schemas.microsoft.com/office/drawing/2014/main" val="2705970781"/>
                    </a:ext>
                  </a:extLst>
                </a:gridCol>
                <a:gridCol w="939475">
                  <a:extLst>
                    <a:ext uri="{9D8B030D-6E8A-4147-A177-3AD203B41FA5}">
                      <a16:colId xmlns:a16="http://schemas.microsoft.com/office/drawing/2014/main" val="3234553872"/>
                    </a:ext>
                  </a:extLst>
                </a:gridCol>
                <a:gridCol w="907522">
                  <a:extLst>
                    <a:ext uri="{9D8B030D-6E8A-4147-A177-3AD203B41FA5}">
                      <a16:colId xmlns:a16="http://schemas.microsoft.com/office/drawing/2014/main" val="2614564167"/>
                    </a:ext>
                  </a:extLst>
                </a:gridCol>
                <a:gridCol w="907522">
                  <a:extLst>
                    <a:ext uri="{9D8B030D-6E8A-4147-A177-3AD203B41FA5}">
                      <a16:colId xmlns:a16="http://schemas.microsoft.com/office/drawing/2014/main" val="3128445651"/>
                    </a:ext>
                  </a:extLst>
                </a:gridCol>
                <a:gridCol w="907522">
                  <a:extLst>
                    <a:ext uri="{9D8B030D-6E8A-4147-A177-3AD203B41FA5}">
                      <a16:colId xmlns:a16="http://schemas.microsoft.com/office/drawing/2014/main" val="1357551717"/>
                    </a:ext>
                  </a:extLst>
                </a:gridCol>
                <a:gridCol w="907522">
                  <a:extLst>
                    <a:ext uri="{9D8B030D-6E8A-4147-A177-3AD203B41FA5}">
                      <a16:colId xmlns:a16="http://schemas.microsoft.com/office/drawing/2014/main" val="2294382312"/>
                    </a:ext>
                  </a:extLst>
                </a:gridCol>
              </a:tblGrid>
              <a:tr h="277399">
                <a:tc>
                  <a:txBody>
                    <a:bodyPr/>
                    <a:lstStyle/>
                    <a:p>
                      <a:pPr algn="ctr" fontAlgn="b"/>
                      <a:endParaRPr lang="en-GB" sz="1200" b="1" i="0" u="none" strike="noStrike" dirty="0"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GB" sz="1400" b="1" i="0" u="none" strike="noStrike" dirty="0">
                          <a:effectLst/>
                          <a:latin typeface="+mn-lt"/>
                        </a:rPr>
                        <a:t>Specific Growth Rate 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GB" sz="1200" b="1" i="0" u="none" strike="noStrike" dirty="0"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GB" sz="1200" b="1" i="0" u="none" strike="noStrike" dirty="0"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GB" sz="1400" b="1" i="0" u="none" strike="noStrike" dirty="0">
                          <a:effectLst/>
                          <a:latin typeface="+mn-lt"/>
                        </a:rPr>
                        <a:t>Doubling Time 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GB" sz="1200" b="1" i="0" u="none" strike="noStrike" dirty="0"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GB" sz="1200" b="1" i="0" u="none" strike="noStrike" dirty="0"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86080434"/>
                  </a:ext>
                </a:extLst>
              </a:tr>
              <a:tr h="34587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i="0" u="none" strike="noStrike" dirty="0">
                          <a:effectLst/>
                          <a:latin typeface="+mn-lt"/>
                        </a:rPr>
                        <a:t>Comparison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i="0" u="none" strike="noStrike" dirty="0">
                          <a:effectLst/>
                          <a:latin typeface="+mn-lt"/>
                        </a:rPr>
                        <a:t>Statistically significant 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i="0" u="none" strike="noStrike" dirty="0">
                          <a:effectLst/>
                          <a:latin typeface="+mn-lt"/>
                        </a:rPr>
                        <a:t>P Value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i="0" u="none" strike="noStrike" dirty="0">
                          <a:effectLst/>
                          <a:latin typeface="+mn-lt"/>
                        </a:rPr>
                        <a:t>Summary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i="0" u="none" strike="noStrike" dirty="0">
                          <a:effectLst/>
                          <a:latin typeface="+mn-lt"/>
                        </a:rPr>
                        <a:t>Statistically significant 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i="0" u="none" strike="noStrike" dirty="0">
                          <a:effectLst/>
                          <a:latin typeface="+mn-lt"/>
                        </a:rPr>
                        <a:t>P Value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i="0" u="none" strike="noStrike" dirty="0">
                          <a:effectLst/>
                          <a:latin typeface="+mn-lt"/>
                        </a:rPr>
                        <a:t>Summary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04729678"/>
                  </a:ext>
                </a:extLst>
              </a:tr>
              <a:tr h="297749"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</a:pPr>
                      <a:r>
                        <a:rPr lang="en-GB" sz="1200" b="0" i="0" u="none" strike="noStrike" dirty="0">
                          <a:effectLst/>
                          <a:latin typeface="+mn-lt"/>
                        </a:rPr>
                        <a:t>Bybe LCA vs. Bybe LCB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GB" sz="1200" b="0" i="0" u="none" strike="noStrike" dirty="0">
                          <a:effectLst/>
                          <a:latin typeface="+mn-lt"/>
                        </a:rPr>
                        <a:t>Yes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GB" sz="1200" b="0" i="0" u="none" strike="noStrike" dirty="0">
                          <a:effectLst/>
                          <a:latin typeface="+mn-lt"/>
                        </a:rPr>
                        <a:t>&lt;0.000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GB" sz="1200" b="0" i="0" u="none" strike="noStrike" dirty="0">
                          <a:effectLst/>
                          <a:latin typeface="+mn-lt"/>
                        </a:rPr>
                        <a:t>****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>
                        <a:lnSpc>
                          <a:spcPct val="100000"/>
                        </a:lnSpc>
                      </a:pPr>
                      <a:r>
                        <a:rPr lang="en-GB" sz="12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Ye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>
                        <a:lnSpc>
                          <a:spcPct val="100000"/>
                        </a:lnSpc>
                      </a:pPr>
                      <a:r>
                        <a:rPr lang="en-GB" sz="12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&lt;0.000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>
                        <a:lnSpc>
                          <a:spcPct val="100000"/>
                        </a:lnSpc>
                      </a:pPr>
                      <a:r>
                        <a:rPr lang="en-GB" sz="12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****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24904762"/>
                  </a:ext>
                </a:extLst>
              </a:tr>
              <a:tr h="280917"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</a:pPr>
                      <a:r>
                        <a:rPr lang="en-GB" sz="1200" b="0" i="0" u="none" strike="noStrike" dirty="0">
                          <a:effectLst/>
                          <a:latin typeface="+mn-lt"/>
                        </a:rPr>
                        <a:t>Bybe LCA vs. Bybe HCA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GB" sz="1200" b="0" i="0" u="none" strike="noStrike" dirty="0">
                          <a:effectLst/>
                          <a:latin typeface="+mn-lt"/>
                        </a:rPr>
                        <a:t>No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GB" sz="1200" b="0" i="0" u="none" strike="noStrike" dirty="0">
                          <a:effectLst/>
                          <a:latin typeface="+mn-lt"/>
                        </a:rPr>
                        <a:t>0.650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GB" sz="1200" b="0" i="0" u="none" strike="noStrike" dirty="0">
                          <a:effectLst/>
                          <a:latin typeface="+mn-lt"/>
                        </a:rPr>
                        <a:t>ns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>
                        <a:lnSpc>
                          <a:spcPct val="100000"/>
                        </a:lnSpc>
                      </a:pPr>
                      <a:r>
                        <a:rPr lang="en-GB" sz="12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No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>
                        <a:lnSpc>
                          <a:spcPct val="100000"/>
                        </a:lnSpc>
                      </a:pPr>
                      <a:r>
                        <a:rPr lang="en-GB" sz="12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0.8789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>
                        <a:lnSpc>
                          <a:spcPct val="100000"/>
                        </a:lnSpc>
                      </a:pPr>
                      <a:r>
                        <a:rPr lang="en-GB" sz="12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n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44709000"/>
                  </a:ext>
                </a:extLst>
              </a:tr>
              <a:tr h="266132"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</a:pPr>
                      <a:r>
                        <a:rPr lang="en-GB" sz="1200" b="0" i="0" u="none" strike="noStrike" dirty="0">
                          <a:effectLst/>
                          <a:latin typeface="+mn-lt"/>
                        </a:rPr>
                        <a:t>Bybe LCA vs. Bybe HCB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GB" sz="1200" b="0" i="0" u="none" strike="noStrike" dirty="0">
                          <a:effectLst/>
                          <a:latin typeface="+mn-lt"/>
                        </a:rPr>
                        <a:t>No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GB" sz="1200" b="0" i="0" u="none" strike="noStrike" dirty="0">
                          <a:effectLst/>
                          <a:latin typeface="+mn-lt"/>
                        </a:rPr>
                        <a:t>0.252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GB" sz="1200" b="0" i="0" u="none" strike="noStrike" dirty="0">
                          <a:effectLst/>
                          <a:latin typeface="+mn-lt"/>
                        </a:rPr>
                        <a:t>ns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>
                        <a:lnSpc>
                          <a:spcPct val="100000"/>
                        </a:lnSpc>
                      </a:pPr>
                      <a:r>
                        <a:rPr lang="en-GB" sz="12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No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>
                        <a:lnSpc>
                          <a:spcPct val="100000"/>
                        </a:lnSpc>
                      </a:pPr>
                      <a:r>
                        <a:rPr lang="en-GB" sz="12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0.351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>
                        <a:lnSpc>
                          <a:spcPct val="100000"/>
                        </a:lnSpc>
                      </a:pPr>
                      <a:r>
                        <a:rPr lang="en-GB" sz="12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n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55581279"/>
                  </a:ext>
                </a:extLst>
              </a:tr>
              <a:tr h="260684"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</a:pPr>
                      <a:r>
                        <a:rPr lang="en-GB" sz="1200" b="0" i="0" u="none" strike="noStrike" dirty="0">
                          <a:effectLst/>
                          <a:latin typeface="+mn-lt"/>
                        </a:rPr>
                        <a:t>Bybe LCB vs. Bybe HCA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GB" sz="1200" b="0" i="0" u="none" strike="noStrike" dirty="0">
                          <a:effectLst/>
                          <a:latin typeface="+mn-lt"/>
                        </a:rPr>
                        <a:t>Yes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GB" sz="1200" b="0" i="0" u="none" strike="noStrike" dirty="0">
                          <a:effectLst/>
                          <a:latin typeface="+mn-lt"/>
                        </a:rPr>
                        <a:t>&lt;0.000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GB" sz="1200" b="0" i="0" u="none" strike="noStrike" dirty="0">
                          <a:effectLst/>
                          <a:latin typeface="+mn-lt"/>
                        </a:rPr>
                        <a:t>****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>
                        <a:lnSpc>
                          <a:spcPct val="100000"/>
                        </a:lnSpc>
                      </a:pPr>
                      <a:r>
                        <a:rPr lang="en-GB" sz="12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Ye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>
                        <a:lnSpc>
                          <a:spcPct val="100000"/>
                        </a:lnSpc>
                      </a:pPr>
                      <a:r>
                        <a:rPr lang="en-GB" sz="12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&lt;0.000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>
                        <a:lnSpc>
                          <a:spcPct val="100000"/>
                        </a:lnSpc>
                      </a:pPr>
                      <a:r>
                        <a:rPr lang="en-GB" sz="12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****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236625"/>
                  </a:ext>
                </a:extLst>
              </a:tr>
              <a:tr h="310488"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</a:pPr>
                      <a:r>
                        <a:rPr lang="en-GB" sz="1200" b="0" i="0" u="none" strike="noStrike" dirty="0">
                          <a:effectLst/>
                          <a:latin typeface="+mn-lt"/>
                        </a:rPr>
                        <a:t>Bybe LCB vs. Bybe HCB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GB" sz="1200" b="0" i="0" u="none" strike="noStrike" dirty="0">
                          <a:effectLst/>
                          <a:latin typeface="+mn-lt"/>
                        </a:rPr>
                        <a:t>Yes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GB" sz="1200" b="0" i="0" u="none" strike="noStrike" dirty="0">
                          <a:effectLst/>
                          <a:latin typeface="+mn-lt"/>
                        </a:rPr>
                        <a:t>&lt;0.000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GB" sz="1200" b="0" i="0" u="none" strike="noStrike" dirty="0">
                          <a:effectLst/>
                          <a:latin typeface="+mn-lt"/>
                        </a:rPr>
                        <a:t>****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>
                        <a:lnSpc>
                          <a:spcPct val="100000"/>
                        </a:lnSpc>
                      </a:pPr>
                      <a:r>
                        <a:rPr lang="en-GB" sz="12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Ye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>
                        <a:lnSpc>
                          <a:spcPct val="100000"/>
                        </a:lnSpc>
                      </a:pPr>
                      <a:r>
                        <a:rPr lang="en-GB" sz="12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&lt;0.000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>
                        <a:lnSpc>
                          <a:spcPct val="100000"/>
                        </a:lnSpc>
                      </a:pPr>
                      <a:r>
                        <a:rPr lang="en-GB" sz="12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****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51040179"/>
                  </a:ext>
                </a:extLst>
              </a:tr>
              <a:tr h="263932"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</a:pPr>
                      <a:r>
                        <a:rPr lang="en-GB" sz="1200" b="0" i="0" u="none" strike="noStrike">
                          <a:effectLst/>
                          <a:latin typeface="+mn-lt"/>
                        </a:rPr>
                        <a:t>Bybe HCA vs. Bybe HCB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GB" sz="1200" b="0" i="0" u="none" strike="noStrike" dirty="0">
                          <a:effectLst/>
                          <a:latin typeface="+mn-lt"/>
                        </a:rPr>
                        <a:t>No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GB" sz="1200" b="0" i="0" u="none" strike="noStrike" dirty="0">
                          <a:effectLst/>
                          <a:latin typeface="+mn-lt"/>
                        </a:rPr>
                        <a:t>0.892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GB" sz="1200" b="0" i="0" u="none" strike="noStrike" dirty="0">
                          <a:effectLst/>
                          <a:latin typeface="+mn-lt"/>
                        </a:rPr>
                        <a:t>ns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>
                        <a:lnSpc>
                          <a:spcPct val="100000"/>
                        </a:lnSpc>
                      </a:pPr>
                      <a:r>
                        <a:rPr lang="en-GB" sz="12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No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>
                        <a:lnSpc>
                          <a:spcPct val="100000"/>
                        </a:lnSpc>
                      </a:pPr>
                      <a:r>
                        <a:rPr lang="en-GB" sz="12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0.791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>
                        <a:lnSpc>
                          <a:spcPct val="100000"/>
                        </a:lnSpc>
                      </a:pPr>
                      <a:r>
                        <a:rPr lang="en-GB" sz="12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n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67362707"/>
                  </a:ext>
                </a:extLst>
              </a:tr>
            </a:tbl>
          </a:graphicData>
        </a:graphic>
      </p:graphicFrame>
      <p:pic>
        <p:nvPicPr>
          <p:cNvPr id="13" name="Picture 12">
            <a:extLst>
              <a:ext uri="{FF2B5EF4-FFF2-40B4-BE49-F238E27FC236}">
                <a16:creationId xmlns:a16="http://schemas.microsoft.com/office/drawing/2014/main" id="{84FE1A07-3FC2-8F49-9BC7-F8238748B5F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37612" y="518973"/>
            <a:ext cx="8697703" cy="299401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9272274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>
            <a:extLst>
              <a:ext uri="{FF2B5EF4-FFF2-40B4-BE49-F238E27FC236}">
                <a16:creationId xmlns:a16="http://schemas.microsoft.com/office/drawing/2014/main" id="{4AA3089E-8B9F-164D-B39E-D479C5ECAC87}"/>
              </a:ext>
            </a:extLst>
          </p:cNvPr>
          <p:cNvSpPr/>
          <p:nvPr/>
        </p:nvSpPr>
        <p:spPr>
          <a:xfrm>
            <a:off x="7676670" y="2076966"/>
            <a:ext cx="4247805" cy="329320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600" b="1" dirty="0"/>
              <a:t>Supplementary Figure 3: Specific growth rate vs. cell productivity for the top 12 mini-pools. </a:t>
            </a:r>
            <a:r>
              <a:rPr lang="en-GB" sz="1600" dirty="0"/>
              <a:t>Graphs plot the cell productivity </a:t>
            </a:r>
            <a:r>
              <a:rPr lang="en-GB" sz="1600" i="1" dirty="0"/>
              <a:t>(pg/cell/day, x-axis</a:t>
            </a:r>
            <a:r>
              <a:rPr lang="en-GB" sz="1600" dirty="0"/>
              <a:t>) against the specific growth rate (</a:t>
            </a:r>
            <a:r>
              <a:rPr lang="en-GB" sz="1600" i="1" dirty="0"/>
              <a:t>µ, y-axis</a:t>
            </a:r>
            <a:r>
              <a:rPr lang="en-GB" sz="1600" dirty="0"/>
              <a:t>) for the top 12 mini-pools for each </a:t>
            </a:r>
            <a:r>
              <a:rPr lang="en-GB" sz="1600" kern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Ybe</a:t>
            </a:r>
            <a:r>
              <a:rPr lang="en-GB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®</a:t>
            </a:r>
            <a:r>
              <a:rPr lang="en-GB" sz="1600" dirty="0"/>
              <a:t> format. The cell specific productivity (</a:t>
            </a:r>
            <a:r>
              <a:rPr lang="en-GB" sz="1600" i="1" dirty="0"/>
              <a:t>qP, pg/cell/day</a:t>
            </a:r>
            <a:r>
              <a:rPr lang="en-GB" sz="1600" dirty="0"/>
              <a:t>) was calculated using the titre measurement (HPLC, mg/L) and corresponding integral of viable cell concentration (x10</a:t>
            </a:r>
            <a:r>
              <a:rPr lang="en-GB" sz="1600" baseline="30000" dirty="0"/>
              <a:t>6</a:t>
            </a:r>
            <a:r>
              <a:rPr lang="en-GB" sz="1600" dirty="0"/>
              <a:t> cells/mL/day) on days 3, 6 and 9 of culture. The specific cell growth (</a:t>
            </a:r>
            <a:r>
              <a:rPr lang="en-GB" sz="1600" i="1" dirty="0"/>
              <a:t>µ, h⁻¹</a:t>
            </a:r>
            <a:r>
              <a:rPr lang="en-GB" sz="1600" dirty="0"/>
              <a:t>) was calculated between days 2 and 4 (exponential growth phase). Linear regression analysis was completed for all plots.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B429C663-7542-1841-9A17-4F8ADCC9517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676670" y="556634"/>
            <a:ext cx="4273160" cy="1274331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D9CD53D9-4663-4838-88B4-1C65126D941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503116" y="5739751"/>
            <a:ext cx="1563451" cy="926086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88B643DD-F757-2844-85D2-2502FA4AABF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15985" y="534510"/>
            <a:ext cx="7560685" cy="520524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8927401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4B5567AE-0C57-3D47-91BA-9ED90CAF5E64}"/>
              </a:ext>
            </a:extLst>
          </p:cNvPr>
          <p:cNvSpPr txBox="1"/>
          <p:nvPr/>
        </p:nvSpPr>
        <p:spPr>
          <a:xfrm>
            <a:off x="125511" y="6041465"/>
            <a:ext cx="11718913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600" b="1" dirty="0"/>
              <a:t>Supplementary Figure 4: Average cell diameter data for each </a:t>
            </a:r>
            <a:r>
              <a:rPr lang="en-GB" sz="1600" b="1" kern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Ybe</a:t>
            </a:r>
            <a:r>
              <a:rPr lang="en-GB" sz="16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®</a:t>
            </a:r>
            <a:r>
              <a:rPr lang="en-US" sz="1600" b="1" dirty="0"/>
              <a:t> cell pool. </a:t>
            </a:r>
            <a:r>
              <a:rPr lang="en-US" sz="1600" dirty="0"/>
              <a:t>The c</a:t>
            </a:r>
            <a:r>
              <a:rPr lang="en-GB" sz="1600" dirty="0"/>
              <a:t>ell diameter (µm) was measured on each day of culture using a Vi-CELL cell counter. </a:t>
            </a:r>
            <a:r>
              <a:rPr lang="en-US" sz="1600" dirty="0"/>
              <a:t>The data summarises the mean diameter (n=12) across all top 12 mini-pools. </a:t>
            </a:r>
            <a:r>
              <a:rPr lang="en-GB" sz="1600" dirty="0"/>
              <a:t>Error bars reflect the mean ± SEM (n=12). 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DB2A2610-BF67-9643-95FE-4CED70160C2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5511" y="478820"/>
            <a:ext cx="10183410" cy="5376213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A711C35A-E5BE-4AA3-AA45-D6D8E6F1D97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684801" y="715326"/>
            <a:ext cx="1563451" cy="92608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357929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1" name="Rectangle 110">
            <a:extLst>
              <a:ext uri="{FF2B5EF4-FFF2-40B4-BE49-F238E27FC236}">
                <a16:creationId xmlns:a16="http://schemas.microsoft.com/office/drawing/2014/main" id="{95C2EE81-5604-8346-9D1E-82F510C84E4D}"/>
              </a:ext>
            </a:extLst>
          </p:cNvPr>
          <p:cNvSpPr/>
          <p:nvPr/>
        </p:nvSpPr>
        <p:spPr>
          <a:xfrm>
            <a:off x="6380038" y="2765119"/>
            <a:ext cx="5266530" cy="304698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600" b="1" dirty="0"/>
              <a:t>Supplementary Figure 5:</a:t>
            </a:r>
            <a:r>
              <a:rPr lang="en-GB" sz="1600" dirty="0"/>
              <a:t> </a:t>
            </a:r>
            <a:r>
              <a:rPr lang="en-GB" sz="1600" b="1" dirty="0"/>
              <a:t>Productivity of all </a:t>
            </a:r>
            <a:r>
              <a:rPr lang="en-GB" sz="1600" b="1" kern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Ybe</a:t>
            </a:r>
            <a:r>
              <a:rPr lang="en-GB" sz="16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®</a:t>
            </a:r>
            <a:r>
              <a:rPr lang="en-GB" sz="1600" b="1" dirty="0"/>
              <a:t> formats. </a:t>
            </a:r>
            <a:r>
              <a:rPr lang="en-GB" sz="1600" dirty="0"/>
              <a:t>Schematics are shown for all formats where each colour (</a:t>
            </a:r>
            <a:r>
              <a:rPr lang="en-GB" sz="1600" i="1" dirty="0"/>
              <a:t>red, blue </a:t>
            </a:r>
            <a:r>
              <a:rPr lang="en-GB" sz="1600" dirty="0"/>
              <a:t>and</a:t>
            </a:r>
            <a:r>
              <a:rPr lang="en-GB" sz="1600" i="1" dirty="0"/>
              <a:t> green</a:t>
            </a:r>
            <a:r>
              <a:rPr lang="en-GB" sz="1600" dirty="0"/>
              <a:t>) represent the three unique antigen targets. Titre measurements were taken using a HPLC (mg/L) from supernatant samples taken on days 3, 6 and 9 of culture. The cell specific productivity (</a:t>
            </a:r>
            <a:r>
              <a:rPr lang="en-GB" sz="1600" i="1" dirty="0"/>
              <a:t>qP, pg/cell/day</a:t>
            </a:r>
            <a:r>
              <a:rPr lang="en-GB" sz="1600" dirty="0"/>
              <a:t>) was calculated using the titre and corresponding integral of viable cell concentration (x10</a:t>
            </a:r>
            <a:r>
              <a:rPr lang="en-GB" sz="1600" baseline="30000" dirty="0"/>
              <a:t>6</a:t>
            </a:r>
            <a:r>
              <a:rPr lang="en-GB" sz="1600" dirty="0"/>
              <a:t> cells/mL/day) on the same days of culture. The tables summarise the range in qP values for the top 12 </a:t>
            </a:r>
            <a:r>
              <a:rPr lang="en-GB" sz="1600" kern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Ybe</a:t>
            </a:r>
            <a:r>
              <a:rPr lang="en-GB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®</a:t>
            </a:r>
            <a:r>
              <a:rPr lang="en-GB" sz="1600" dirty="0"/>
              <a:t> mini-pools in descending order. The fold difference (FD) between the top- and bottom-ranking mini-pool is also highlighted.</a:t>
            </a:r>
            <a:r>
              <a:rPr lang="en-GB" sz="1600" b="1" dirty="0"/>
              <a:t> </a:t>
            </a:r>
            <a:endParaRPr lang="en-GB" sz="1600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29B61900-8D5D-B442-B17D-3908D0C052B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84677" y="480857"/>
            <a:ext cx="5963508" cy="620154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3490705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638CC0F6-12C2-9343-97DC-174E37DC757E}"/>
              </a:ext>
            </a:extLst>
          </p:cNvPr>
          <p:cNvSpPr txBox="1"/>
          <p:nvPr/>
        </p:nvSpPr>
        <p:spPr>
          <a:xfrm>
            <a:off x="8488905" y="512102"/>
            <a:ext cx="3565720" cy="55092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600" b="1" dirty="0"/>
              <a:t>Supplementary Figure 6</a:t>
            </a:r>
            <a:r>
              <a:rPr lang="en-US" sz="1600" dirty="0"/>
              <a:t>: </a:t>
            </a:r>
            <a:r>
              <a:rPr lang="en-US" sz="1600" b="1" dirty="0"/>
              <a:t>Analysis of intracellular heavy and light chain in cell lysate samples for all cell pools. </a:t>
            </a:r>
            <a:r>
              <a:rPr lang="en-GB" sz="1600" dirty="0"/>
              <a:t>Cell lysates were harvested on day 6 of culture (end of exponential growth phase) for intracellular protein analysis for all </a:t>
            </a:r>
            <a:r>
              <a:rPr lang="en-GB" sz="1600" kern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Ybe</a:t>
            </a:r>
            <a:r>
              <a:rPr lang="en-GB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®</a:t>
            </a:r>
            <a:r>
              <a:rPr lang="en-GB" sz="1600" dirty="0"/>
              <a:t> mini-pools. Samples were analysed by western blot under reducing conditions (with 1.8% (v/v) β-</a:t>
            </a:r>
            <a:r>
              <a:rPr lang="en-GB" sz="1600" dirty="0" err="1"/>
              <a:t>mercaptoethanol</a:t>
            </a:r>
            <a:r>
              <a:rPr lang="en-GB" sz="1600" dirty="0"/>
              <a:t>) and probed for heavy and light chain on the same blot. ERK2 was used as an intracellular loading control. Western blot images are shown for for 8 out of 12 mini-pools selected for each cell line with a range in qP. The mini-pools selected were of high qP (ranks 1, 2 and 3), mid qP (ranks 5, 7 and 9) and low qP (Ranks 11 and 12). Data is shown in rank order (decreasing qP). A commercial IgG was used as a positive control (IgG control). Data shown is representative of three replicates (n=3).</a:t>
            </a:r>
          </a:p>
        </p:txBody>
      </p:sp>
      <p:pic>
        <p:nvPicPr>
          <p:cNvPr id="17" name="Picture 16">
            <a:extLst>
              <a:ext uri="{FF2B5EF4-FFF2-40B4-BE49-F238E27FC236}">
                <a16:creationId xmlns:a16="http://schemas.microsoft.com/office/drawing/2014/main" id="{2AF818E7-2D24-4603-8699-DC7ECFBD477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491174" y="5931914"/>
            <a:ext cx="1563451" cy="926086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01CB7A46-1B67-8448-A372-07E604AB459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9808" y="512102"/>
            <a:ext cx="8451181" cy="6129330"/>
          </a:xfrm>
          <a:prstGeom prst="rect">
            <a:avLst/>
          </a:prstGeom>
        </p:spPr>
      </p:pic>
      <p:sp>
        <p:nvSpPr>
          <p:cNvPr id="13" name="Rectangle 12">
            <a:extLst>
              <a:ext uri="{FF2B5EF4-FFF2-40B4-BE49-F238E27FC236}">
                <a16:creationId xmlns:a16="http://schemas.microsoft.com/office/drawing/2014/main" id="{1837F4B4-87A3-BE49-B16E-E20BF74E295C}"/>
              </a:ext>
            </a:extLst>
          </p:cNvPr>
          <p:cNvSpPr/>
          <p:nvPr/>
        </p:nvSpPr>
        <p:spPr>
          <a:xfrm>
            <a:off x="69808" y="437446"/>
            <a:ext cx="7885156" cy="35394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/>
              <a:t>A                                                                            B</a:t>
            </a:r>
          </a:p>
          <a:p>
            <a:endParaRPr lang="en-GB" b="1" dirty="0"/>
          </a:p>
          <a:p>
            <a:endParaRPr lang="en-GB" b="1" dirty="0"/>
          </a:p>
          <a:p>
            <a:endParaRPr lang="en-GB" b="1" dirty="0"/>
          </a:p>
          <a:p>
            <a:endParaRPr lang="en-GB" b="1" dirty="0"/>
          </a:p>
          <a:p>
            <a:endParaRPr lang="en-GB" b="1" dirty="0"/>
          </a:p>
          <a:p>
            <a:endParaRPr lang="en-GB" b="1" dirty="0"/>
          </a:p>
          <a:p>
            <a:endParaRPr lang="en-GB" b="1" dirty="0"/>
          </a:p>
          <a:p>
            <a:endParaRPr lang="en-GB" b="1" dirty="0"/>
          </a:p>
          <a:p>
            <a:endParaRPr lang="en-GB" b="1" dirty="0"/>
          </a:p>
          <a:p>
            <a:endParaRPr lang="en-GB" sz="800" b="1" dirty="0"/>
          </a:p>
          <a:p>
            <a:endParaRPr lang="en-GB" b="1" dirty="0"/>
          </a:p>
          <a:p>
            <a:r>
              <a:rPr lang="en-GB" b="1" dirty="0"/>
              <a:t>C                                                                              D</a:t>
            </a:r>
          </a:p>
        </p:txBody>
      </p:sp>
    </p:spTree>
    <p:extLst>
      <p:ext uri="{BB962C8B-B14F-4D97-AF65-F5344CB8AC3E}">
        <p14:creationId xmlns:p14="http://schemas.microsoft.com/office/powerpoint/2010/main" val="269467495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D7DC920B-3E50-284E-AD88-59F17CCA0F34}"/>
              </a:ext>
            </a:extLst>
          </p:cNvPr>
          <p:cNvSpPr txBox="1"/>
          <p:nvPr/>
        </p:nvSpPr>
        <p:spPr>
          <a:xfrm>
            <a:off x="119973" y="5231036"/>
            <a:ext cx="10002595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600" b="1" dirty="0"/>
              <a:t>Supplementary Figure 7</a:t>
            </a:r>
            <a:r>
              <a:rPr lang="en-US" sz="1600" dirty="0"/>
              <a:t>:</a:t>
            </a:r>
            <a:r>
              <a:rPr lang="en-US" sz="1600" b="1" dirty="0"/>
              <a:t> SDS-PAGE analysis of secreted protein culture medium samples for all </a:t>
            </a:r>
            <a:r>
              <a:rPr lang="en-GB" sz="1600" b="1" kern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Ybe</a:t>
            </a:r>
            <a:r>
              <a:rPr lang="en-GB" sz="16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®</a:t>
            </a:r>
            <a:r>
              <a:rPr lang="en-US" sz="1600" b="1" dirty="0"/>
              <a:t> formats. </a:t>
            </a:r>
            <a:r>
              <a:rPr lang="en-GB" sz="1600" dirty="0"/>
              <a:t>Culture medium was harvested on day 6 of culture (exponential growth phase) for secreted protein analysis. Samples were analysed by SDS-PAGE under non-reducing conditions. The top (R1) and bottom (R12) ranking mini-pools were selected for each cell line. Culture medium from a non-transfected host cell line culture (Host </a:t>
            </a:r>
            <a:r>
              <a:rPr lang="en-GB" sz="1600" dirty="0" err="1"/>
              <a:t>Ctl</a:t>
            </a:r>
            <a:r>
              <a:rPr lang="en-GB" sz="1600" dirty="0"/>
              <a:t>) was used a negative control. A commercial IgG was used as a positive control (IgG control). </a:t>
            </a: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9CAF2AD0-E4A9-495B-9DE4-DDA66C2A087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215014" y="1920447"/>
            <a:ext cx="2817776" cy="1669066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5EDC318E-B6D6-B940-A9AF-57D79F1D894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300788"/>
            <a:ext cx="5454316" cy="478498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9621702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7838F8C2-A507-D446-94F4-7BE8DB46596F}"/>
              </a:ext>
            </a:extLst>
          </p:cNvPr>
          <p:cNvSpPr txBox="1"/>
          <p:nvPr/>
        </p:nvSpPr>
        <p:spPr>
          <a:xfrm>
            <a:off x="165962" y="5209698"/>
            <a:ext cx="11735578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600" b="1" dirty="0"/>
              <a:t>Supplementary Figure 8: Analysis of intracellular heavy and light chain in cell lysate samples under non-reducing conditions. </a:t>
            </a:r>
            <a:r>
              <a:rPr lang="en-GB" sz="1600" dirty="0"/>
              <a:t>Cell pellets were harvested on day 6 of culture (end of exponential growth phase) for intracellular protein analysis. Samples were analysed by western blot under non-reducing conditions. Images are shown for the light chain (</a:t>
            </a:r>
            <a:r>
              <a:rPr lang="en-GB" sz="1600" b="1" dirty="0"/>
              <a:t>A</a:t>
            </a:r>
            <a:r>
              <a:rPr lang="en-GB" sz="1600" dirty="0"/>
              <a:t>) and heavy chain (</a:t>
            </a:r>
            <a:r>
              <a:rPr lang="en-GB" sz="1600" b="1" dirty="0"/>
              <a:t>B</a:t>
            </a:r>
            <a:r>
              <a:rPr lang="en-GB" sz="1600" dirty="0"/>
              <a:t>). Data is shown for top (R1) and bottom (R12) ranking mini-pools selected for each molecule. A cell lysate sample from the non-transfected host cell line culture (Host </a:t>
            </a:r>
            <a:r>
              <a:rPr lang="en-GB" sz="1600" dirty="0" err="1"/>
              <a:t>Ctl</a:t>
            </a:r>
            <a:r>
              <a:rPr lang="en-GB" sz="1600" dirty="0"/>
              <a:t>) was used as a negative control. A commercial IgG was used as a positive control (IgG control). Data shown is representative of at least three replicates.</a:t>
            </a: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A3393789-FAAD-4047-8FA8-FE62DF48866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456739" y="3766992"/>
            <a:ext cx="1563451" cy="926086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90692909-0366-5A4F-8C04-B04705EBE1B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5962" y="642268"/>
            <a:ext cx="9563100" cy="4432300"/>
          </a:xfrm>
          <a:prstGeom prst="rect">
            <a:avLst/>
          </a:prstGeom>
        </p:spPr>
      </p:pic>
      <p:sp>
        <p:nvSpPr>
          <p:cNvPr id="7" name="Rectangle 6">
            <a:extLst>
              <a:ext uri="{FF2B5EF4-FFF2-40B4-BE49-F238E27FC236}">
                <a16:creationId xmlns:a16="http://schemas.microsoft.com/office/drawing/2014/main" id="{E11689C1-4CA5-6344-BD4C-C5B3766182EC}"/>
              </a:ext>
            </a:extLst>
          </p:cNvPr>
          <p:cNvSpPr/>
          <p:nvPr/>
        </p:nvSpPr>
        <p:spPr>
          <a:xfrm>
            <a:off x="165962" y="627671"/>
            <a:ext cx="788515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/>
              <a:t>A                                                                                         B</a:t>
            </a:r>
          </a:p>
        </p:txBody>
      </p:sp>
    </p:spTree>
    <p:extLst>
      <p:ext uri="{BB962C8B-B14F-4D97-AF65-F5344CB8AC3E}">
        <p14:creationId xmlns:p14="http://schemas.microsoft.com/office/powerpoint/2010/main" val="34267807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182</TotalTime>
  <Words>1544</Words>
  <Application>Microsoft Macintosh PowerPoint</Application>
  <PresentationFormat>Widescreen</PresentationFormat>
  <Paragraphs>93</Paragraphs>
  <Slides>12</Slides>
  <Notes>5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2</vt:i4>
      </vt:variant>
    </vt:vector>
  </HeadingPairs>
  <TitlesOfParts>
    <vt:vector size="17" baseType="lpstr">
      <vt:lpstr>Arial</vt:lpstr>
      <vt:lpstr>Calibri</vt:lpstr>
      <vt:lpstr>Calibri Light</vt:lpstr>
      <vt:lpstr>Calibri-Bold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LINK PAPER 2 – Bybes &amp; Trybes</dc:title>
  <dc:creator>Angelica</dc:creator>
  <cp:lastModifiedBy>Mark Smales</cp:lastModifiedBy>
  <cp:revision>294</cp:revision>
  <dcterms:created xsi:type="dcterms:W3CDTF">2021-01-22T11:11:05Z</dcterms:created>
  <dcterms:modified xsi:type="dcterms:W3CDTF">2024-10-14T17:50:10Z</dcterms:modified>
</cp:coreProperties>
</file>